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56" r:id="rId3"/>
    <p:sldId id="257" r:id="rId4"/>
    <p:sldId id="267" r:id="rId5"/>
    <p:sldId id="260" r:id="rId6"/>
    <p:sldId id="269" r:id="rId7"/>
    <p:sldId id="261" r:id="rId8"/>
    <p:sldId id="263" r:id="rId9"/>
    <p:sldId id="265" r:id="rId10"/>
  </p:sldIdLst>
  <p:sldSz cx="9144000" cy="6858000" type="screen4x3"/>
  <p:notesSz cx="7004050" cy="9283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246" y="-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C348C-16F6-460A-9FEF-BB884B899145}" type="datetimeFigureOut">
              <a:rPr lang="en-US" smtClean="0"/>
              <a:pPr/>
              <a:t>11/4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2D067-26BE-4C44-AF0E-84F97A96DC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C348C-16F6-460A-9FEF-BB884B899145}" type="datetimeFigureOut">
              <a:rPr lang="en-US" smtClean="0"/>
              <a:pPr/>
              <a:t>11/4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2D067-26BE-4C44-AF0E-84F97A96DC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C348C-16F6-460A-9FEF-BB884B899145}" type="datetimeFigureOut">
              <a:rPr lang="en-US" smtClean="0"/>
              <a:pPr/>
              <a:t>11/4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2D067-26BE-4C44-AF0E-84F97A96DC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C348C-16F6-460A-9FEF-BB884B899145}" type="datetimeFigureOut">
              <a:rPr lang="en-US" smtClean="0"/>
              <a:pPr/>
              <a:t>11/4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2D067-26BE-4C44-AF0E-84F97A96DC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C348C-16F6-460A-9FEF-BB884B899145}" type="datetimeFigureOut">
              <a:rPr lang="en-US" smtClean="0"/>
              <a:pPr/>
              <a:t>11/4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2D067-26BE-4C44-AF0E-84F97A96DC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C348C-16F6-460A-9FEF-BB884B899145}" type="datetimeFigureOut">
              <a:rPr lang="en-US" smtClean="0"/>
              <a:pPr/>
              <a:t>11/4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2D067-26BE-4C44-AF0E-84F97A96DC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C348C-16F6-460A-9FEF-BB884B899145}" type="datetimeFigureOut">
              <a:rPr lang="en-US" smtClean="0"/>
              <a:pPr/>
              <a:t>11/4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2D067-26BE-4C44-AF0E-84F97A96DC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C348C-16F6-460A-9FEF-BB884B899145}" type="datetimeFigureOut">
              <a:rPr lang="en-US" smtClean="0"/>
              <a:pPr/>
              <a:t>11/4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2D067-26BE-4C44-AF0E-84F97A96DC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C348C-16F6-460A-9FEF-BB884B899145}" type="datetimeFigureOut">
              <a:rPr lang="en-US" smtClean="0"/>
              <a:pPr/>
              <a:t>11/4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2D067-26BE-4C44-AF0E-84F97A96DC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C348C-16F6-460A-9FEF-BB884B899145}" type="datetimeFigureOut">
              <a:rPr lang="en-US" smtClean="0"/>
              <a:pPr/>
              <a:t>11/4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2D067-26BE-4C44-AF0E-84F97A96DC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C348C-16F6-460A-9FEF-BB884B899145}" type="datetimeFigureOut">
              <a:rPr lang="en-US" smtClean="0"/>
              <a:pPr/>
              <a:t>11/4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2D067-26BE-4C44-AF0E-84F97A96DC7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C348C-16F6-460A-9FEF-BB884B899145}" type="datetimeFigureOut">
              <a:rPr lang="en-US" smtClean="0"/>
              <a:pPr/>
              <a:t>11/4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B2D067-26BE-4C44-AF0E-84F97A96DC7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0" y="457200"/>
            <a:ext cx="8229600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/>
            <a:r>
              <a:rPr lang="en-US" b="1" dirty="0" smtClean="0"/>
              <a:t>Figure S1. </a:t>
            </a:r>
            <a:r>
              <a:rPr lang="en-US" dirty="0" smtClean="0"/>
              <a:t>Median joining (MJ) </a:t>
            </a:r>
            <a:r>
              <a:rPr lang="en-US" dirty="0" err="1" smtClean="0"/>
              <a:t>haplotype</a:t>
            </a:r>
            <a:r>
              <a:rPr lang="en-US" dirty="0" smtClean="0"/>
              <a:t> networks constructed for bovine </a:t>
            </a:r>
            <a:r>
              <a:rPr lang="en-US" i="1" dirty="0" smtClean="0"/>
              <a:t>TLR1, TLR2, TLR4, TLR5, TLR6, TLR7, and TLR9</a:t>
            </a:r>
            <a:r>
              <a:rPr lang="en-US" dirty="0" smtClean="0"/>
              <a:t> using </a:t>
            </a:r>
            <a:r>
              <a:rPr lang="en-US" dirty="0" err="1" smtClean="0"/>
              <a:t>haplotypes</a:t>
            </a:r>
            <a:r>
              <a:rPr lang="en-US" dirty="0" smtClean="0"/>
              <a:t> predicted for all cattle.  For all loci except TLR7, all cattle is defined as follows: n = 96 AI sires, 31 breeds; 48 Purebred Angus; 405 Holstein cattle. For TLR7, only the sequencing discovery panel was genotyped and is represented (n = 96 AI sires, 31 breeds). Because MJ networks require the absence of recombination [</a:t>
            </a:r>
            <a:r>
              <a:rPr lang="en-US" dirty="0" smtClean="0"/>
              <a:t>66], </a:t>
            </a:r>
            <a:r>
              <a:rPr lang="en-US" dirty="0" smtClean="0"/>
              <a:t>each network represents intragenic regions of elevated LD.  </a:t>
            </a:r>
            <a:r>
              <a:rPr lang="en-US" dirty="0" err="1" smtClean="0"/>
              <a:t>Haplotypes</a:t>
            </a:r>
            <a:r>
              <a:rPr lang="en-US" dirty="0" smtClean="0"/>
              <a:t> predicted for </a:t>
            </a:r>
            <a:r>
              <a:rPr lang="en-US" i="1" dirty="0" smtClean="0"/>
              <a:t>B. t. </a:t>
            </a:r>
            <a:r>
              <a:rPr lang="en-US" i="1" dirty="0" err="1" smtClean="0"/>
              <a:t>taurus</a:t>
            </a:r>
            <a:r>
              <a:rPr lang="en-US" dirty="0" smtClean="0"/>
              <a:t>, </a:t>
            </a:r>
            <a:r>
              <a:rPr lang="en-US" i="1" dirty="0" smtClean="0"/>
              <a:t>B. t. </a:t>
            </a:r>
            <a:r>
              <a:rPr lang="en-US" i="1" dirty="0" err="1" smtClean="0"/>
              <a:t>indicus</a:t>
            </a:r>
            <a:r>
              <a:rPr lang="en-US" dirty="0" smtClean="0"/>
              <a:t> and</a:t>
            </a:r>
            <a:r>
              <a:rPr lang="en-US" i="1" dirty="0" smtClean="0"/>
              <a:t> </a:t>
            </a:r>
            <a:r>
              <a:rPr lang="en-US" dirty="0" smtClean="0"/>
              <a:t>hybrids (termed “composites”) are color coded.  Numbers indicate SNP and </a:t>
            </a:r>
            <a:r>
              <a:rPr lang="en-US" dirty="0" err="1" smtClean="0"/>
              <a:t>indel</a:t>
            </a:r>
            <a:r>
              <a:rPr lang="en-US" dirty="0" smtClean="0"/>
              <a:t> positions in numerical order (see Table S2 for SNP information).  Node sizes are proportional to </a:t>
            </a:r>
            <a:r>
              <a:rPr lang="en-US" dirty="0" err="1" smtClean="0"/>
              <a:t>haplotype</a:t>
            </a:r>
            <a:r>
              <a:rPr lang="en-US" dirty="0" smtClean="0"/>
              <a:t> frequency, and all branch lengths are drawn to scale.  Alphabetized letters at nodes represent the breed distribution of each </a:t>
            </a:r>
            <a:r>
              <a:rPr lang="en-US" dirty="0" err="1" smtClean="0"/>
              <a:t>haplotype</a:t>
            </a:r>
            <a:r>
              <a:rPr lang="en-US" dirty="0" smtClean="0"/>
              <a:t> (Table S4). Median vectors are indicated as “</a:t>
            </a:r>
            <a:r>
              <a:rPr lang="en-US" dirty="0" err="1" smtClean="0"/>
              <a:t>mv</a:t>
            </a:r>
            <a:r>
              <a:rPr lang="en-US" dirty="0" smtClean="0"/>
              <a:t>”.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Documents and Settings\CSeabury\Desktop\454BovineTLRResults\2011USDA_PNAS_fastasNetworks\TLR1FastaSelectionCAF\TLR1_FinalCMS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-10333"/>
            <a:ext cx="9144000" cy="6868333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4733370" y="552674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5715000" y="37338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821705" y="4876800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7974105" y="2667000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992470" y="394445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E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4724400" y="1002268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617260" y="3489973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G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218765" y="5767008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H</a:t>
            </a:r>
            <a:endParaRPr lang="en-US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3352800" y="35116"/>
            <a:ext cx="259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/>
              <a:t>TLR1 </a:t>
            </a:r>
          </a:p>
          <a:p>
            <a:pPr algn="ctr"/>
            <a:r>
              <a:rPr lang="en-US" sz="2000" dirty="0" smtClean="0"/>
              <a:t>5 SNPs: Positions 1-5</a:t>
            </a:r>
            <a:endParaRPr lang="en-US" sz="20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Documents and Settings\CSeabury\Desktop\454BovineTLRResults\2011USDA_PNAS_fastasNetworks\TLR2FastaSelection\TLR2BrokenSeg1\TLR2BrokenSeg1_ModifiedIndelCMS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3276600" y="44390"/>
            <a:ext cx="25908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/>
              <a:t>TLR2 Network 1</a:t>
            </a:r>
          </a:p>
          <a:p>
            <a:pPr algn="ctr"/>
            <a:r>
              <a:rPr lang="en-US" sz="2000" dirty="0" smtClean="0"/>
              <a:t>28 SNPs and 1 </a:t>
            </a:r>
            <a:r>
              <a:rPr lang="en-US" sz="2000" dirty="0" err="1" smtClean="0"/>
              <a:t>Indel</a:t>
            </a:r>
            <a:r>
              <a:rPr lang="en-US" sz="2000" dirty="0" smtClean="0"/>
              <a:t>: Positions 1-29</a:t>
            </a:r>
            <a:endParaRPr lang="en-US" sz="2000" dirty="0"/>
          </a:p>
        </p:txBody>
      </p:sp>
      <p:sp>
        <p:nvSpPr>
          <p:cNvPr id="4" name="TextBox 3"/>
          <p:cNvSpPr txBox="1"/>
          <p:nvPr/>
        </p:nvSpPr>
        <p:spPr>
          <a:xfrm>
            <a:off x="2024330" y="5157156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804356" y="591053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2869722" y="508814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2819400" y="55742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D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2635364" y="5874592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E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990600" y="631039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201948" y="5528096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G</a:t>
            </a:r>
            <a:endParaRPr lang="en-US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1293966" y="5079522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H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891390" y="55742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I</a:t>
            </a:r>
            <a:endParaRPr lang="en-US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474452" y="5761172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J</a:t>
            </a:r>
            <a:endParaRPr lang="en-US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609600" y="4672644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K</a:t>
            </a:r>
            <a:endParaRPr lang="en-US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371600" y="4682704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L</a:t>
            </a:r>
            <a:endParaRPr lang="en-US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1600200" y="4385096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M</a:t>
            </a:r>
            <a:endParaRPr lang="en-US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1948130" y="4241322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N</a:t>
            </a:r>
            <a:endParaRPr lang="en-US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2606618" y="4465772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O</a:t>
            </a:r>
            <a:endParaRPr lang="en-US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2455652" y="376687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P</a:t>
            </a:r>
            <a:endParaRPr lang="en-US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1752600" y="3470696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Q</a:t>
            </a:r>
            <a:endParaRPr lang="en-US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1050982" y="3293852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R</a:t>
            </a:r>
            <a:endParaRPr lang="en-US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211348" y="3089696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T</a:t>
            </a:r>
            <a:endParaRPr lang="en-US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202722" y="3608886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</a:t>
            </a:r>
            <a:endParaRPr lang="en-US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5815644" y="48307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U</a:t>
            </a:r>
            <a:endParaRPr lang="en-US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6671096" y="3048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V</a:t>
            </a:r>
            <a:endParaRPr lang="en-US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7848600" y="6858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W</a:t>
            </a:r>
            <a:endParaRPr lang="en-US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8187904" y="-2587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X</a:t>
            </a:r>
            <a:endParaRPr lang="en-US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8636478" y="126522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Y</a:t>
            </a:r>
            <a:endParaRPr lang="en-US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8788878" y="3926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Z</a:t>
            </a:r>
            <a:endParaRPr lang="en-US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8025444" y="1311218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B</a:t>
            </a:r>
            <a:endParaRPr lang="en-US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7450348" y="1857720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C</a:t>
            </a:r>
            <a:endParaRPr lang="en-US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5740878" y="3134260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E</a:t>
            </a:r>
            <a:endParaRPr lang="en-US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5926348" y="2175296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D</a:t>
            </a:r>
            <a:endParaRPr lang="en-US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5647426" y="1421922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7239000" y="9906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Documents and Settings\CSeabury\Desktop\454BovineTLRResults\2011USDA_PNAS_fastasNetworks\TLR2FastaSelection\TLR2BrokenSeg2\TLR2BrokenSeg2_NumbersUpdated_CMS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-1"/>
            <a:ext cx="9144000" cy="6858001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6858000" y="0"/>
            <a:ext cx="2286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/>
              <a:t>TLR2 Network 2</a:t>
            </a:r>
          </a:p>
          <a:p>
            <a:pPr algn="ctr"/>
            <a:r>
              <a:rPr lang="en-US" sz="2000" dirty="0" smtClean="0"/>
              <a:t>15 SNPs:</a:t>
            </a:r>
          </a:p>
          <a:p>
            <a:pPr algn="ctr"/>
            <a:r>
              <a:rPr lang="en-US" sz="2000" dirty="0" smtClean="0"/>
              <a:t>Positions 31-45</a:t>
            </a:r>
            <a:endParaRPr lang="en-US" sz="2000" dirty="0"/>
          </a:p>
        </p:txBody>
      </p:sp>
      <p:sp>
        <p:nvSpPr>
          <p:cNvPr id="4" name="TextBox 3"/>
          <p:cNvSpPr txBox="1"/>
          <p:nvPr/>
        </p:nvSpPr>
        <p:spPr>
          <a:xfrm>
            <a:off x="3352800" y="593782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3920704" y="-8626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E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4419600" y="475886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2895600" y="14594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D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2311878" y="278922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1989826" y="1239494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904226" y="2661416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G</a:t>
            </a:r>
            <a:endParaRPr lang="en-US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6307348" y="5756696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H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7197304" y="528672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I</a:t>
            </a:r>
            <a:endParaRPr lang="en-US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7315200" y="64124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J</a:t>
            </a:r>
            <a:endParaRPr lang="en-US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8415070" y="629153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K</a:t>
            </a:r>
            <a:endParaRPr lang="en-US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7916174" y="56388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L</a:t>
            </a:r>
            <a:endParaRPr lang="en-US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8406444" y="455474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M</a:t>
            </a:r>
            <a:endParaRPr lang="en-US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3971026" y="1465052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6324600" y="4734949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Documents and Settings\CSeabury\Desktop\454BovineTLRResults\2011USDA_PNAS_fastasNetworks\TLR4FastaSelection\TLR4PrepFinal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0" y="4572000"/>
            <a:ext cx="2133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/>
              <a:t>TLR4 </a:t>
            </a:r>
          </a:p>
          <a:p>
            <a:pPr algn="ctr"/>
            <a:r>
              <a:rPr lang="en-US" sz="2000" dirty="0" smtClean="0"/>
              <a:t>27 SNPs: </a:t>
            </a:r>
          </a:p>
          <a:p>
            <a:pPr algn="ctr"/>
            <a:r>
              <a:rPr lang="en-US" sz="2000" dirty="0" smtClean="0"/>
              <a:t>Positions 1-26, 28</a:t>
            </a:r>
            <a:endParaRPr lang="en-US" sz="2000" dirty="0"/>
          </a:p>
        </p:txBody>
      </p:sp>
      <p:sp>
        <p:nvSpPr>
          <p:cNvPr id="4" name="TextBox 3"/>
          <p:cNvSpPr txBox="1"/>
          <p:nvPr/>
        </p:nvSpPr>
        <p:spPr>
          <a:xfrm>
            <a:off x="6629400" y="4114800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7942556" y="4176034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7924800" y="4507468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7781278" y="4946912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D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7543800" y="5283522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E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8713434" y="5498068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8794810" y="6107668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G</a:t>
            </a:r>
            <a:endParaRPr lang="en-US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6122634" y="5435922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H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5105400" y="5486400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I</a:t>
            </a:r>
            <a:endParaRPr lang="en-US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5442010" y="4226512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J</a:t>
            </a:r>
            <a:endParaRPr lang="en-US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5576654" y="3698288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K</a:t>
            </a:r>
            <a:endParaRPr lang="en-US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6207712" y="2980678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L</a:t>
            </a:r>
            <a:endParaRPr lang="en-US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4343400" y="3440668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N</a:t>
            </a:r>
            <a:endParaRPr lang="en-US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4405546" y="4341014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O</a:t>
            </a:r>
            <a:endParaRPr lang="en-US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4114800" y="4475658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P</a:t>
            </a:r>
            <a:endParaRPr lang="en-US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3795946" y="3048000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Q</a:t>
            </a:r>
            <a:endParaRPr lang="en-US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4003088" y="2564166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R</a:t>
            </a:r>
            <a:endParaRPr lang="en-US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2667000" y="2590800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</a:t>
            </a:r>
            <a:endParaRPr lang="en-US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1725966" y="3575312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T</a:t>
            </a:r>
            <a:endParaRPr lang="en-US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1577268" y="2044820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U</a:t>
            </a:r>
            <a:endParaRPr lang="en-US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2555288" y="1407112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V</a:t>
            </a:r>
            <a:endParaRPr lang="en-US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2725444" y="1975112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W</a:t>
            </a:r>
            <a:endParaRPr lang="en-US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3900254" y="1415078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X</a:t>
            </a:r>
            <a:endParaRPr lang="en-US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3733800" y="796600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Y</a:t>
            </a:r>
            <a:endParaRPr lang="en-US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4975932" y="2971800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M</a:t>
            </a:r>
            <a:endParaRPr lang="en-US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6113756" y="1705824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Z</a:t>
            </a:r>
            <a:endParaRPr lang="en-US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7162800" y="1066800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B</a:t>
            </a:r>
            <a:endParaRPr lang="en-US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5996868" y="372122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C</a:t>
            </a:r>
            <a:endParaRPr lang="en-US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2514600" y="304800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D</a:t>
            </a:r>
            <a:endParaRPr lang="en-US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8624654" y="21336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8458200" y="9906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7526044" y="161278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Documents and Settings\CSeabury\Desktop\454BovineTLRResults\2011USDA_PNAS_fastasNetworks\TLR5FastaSelection\Revised307-2NoHeteroNonsense\TLR5FinalD-IisCModifiedRevised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4495800" y="44390"/>
            <a:ext cx="25908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/>
              <a:t>TLR5 </a:t>
            </a:r>
          </a:p>
          <a:p>
            <a:pPr algn="ctr"/>
            <a:r>
              <a:rPr lang="en-US" sz="2000" dirty="0" smtClean="0"/>
              <a:t>43 SNPs and 3 </a:t>
            </a:r>
            <a:r>
              <a:rPr lang="en-US" sz="2000" dirty="0" err="1" smtClean="0"/>
              <a:t>Indels</a:t>
            </a:r>
            <a:r>
              <a:rPr lang="en-US" sz="2000" dirty="0" smtClean="0"/>
              <a:t>: Positions 1-46</a:t>
            </a:r>
            <a:endParaRPr lang="en-US" sz="2000" dirty="0"/>
          </a:p>
        </p:txBody>
      </p:sp>
      <p:sp>
        <p:nvSpPr>
          <p:cNvPr id="4" name="TextBox 3"/>
          <p:cNvSpPr txBox="1"/>
          <p:nvPr/>
        </p:nvSpPr>
        <p:spPr>
          <a:xfrm>
            <a:off x="8335113" y="121920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8809888" y="53340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8428888" y="38100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8044130" y="439948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772400" y="586764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E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7621434" y="83820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326810" y="2025938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G</a:t>
            </a:r>
            <a:endParaRPr lang="en-US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7493478" y="1726722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H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578304" y="2069068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I</a:t>
            </a:r>
            <a:endParaRPr lang="en-US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6824930" y="219559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J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7505862" y="2540478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K</a:t>
            </a:r>
            <a:endParaRPr lang="en-US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7971688" y="3821668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L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8068574" y="2888897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261670" y="6159424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M</a:t>
            </a:r>
            <a:endParaRPr lang="en-US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1172636" y="6329076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N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180488" y="182880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O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632496" y="1863304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P</a:t>
            </a:r>
            <a:endParaRPr lang="en-US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3035940" y="213360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T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592582" y="2047340"/>
            <a:ext cx="312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W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031327" y="1828800"/>
            <a:ext cx="312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V</a:t>
            </a:r>
            <a:endParaRPr lang="en-US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4216797" y="1066800"/>
            <a:ext cx="312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U</a:t>
            </a:r>
            <a:endParaRPr lang="en-US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3818626" y="626852"/>
            <a:ext cx="312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Q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352800" y="329244"/>
            <a:ext cx="312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</a:t>
            </a:r>
            <a:endParaRPr lang="en-US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3352800" y="1154668"/>
            <a:ext cx="312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R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625304" y="976390"/>
            <a:ext cx="312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X</a:t>
            </a:r>
            <a:endParaRPr lang="en-US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1600200" y="2777704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-17252" y="26670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720304" y="2974842"/>
            <a:ext cx="312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Z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5520823" y="3643390"/>
            <a:ext cx="312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Y</a:t>
            </a:r>
            <a:endParaRPr lang="en-US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4528870" y="2332172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B</a:t>
            </a:r>
            <a:endParaRPr lang="en-US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4970252" y="3288268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C</a:t>
            </a:r>
            <a:endParaRPr lang="en-US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3962400" y="3252156"/>
            <a:ext cx="583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D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4000495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Documents and Settings\CSeabury\Desktop\454BovineTLRResults\2011USDA_PNAS_fastasNetworks\TLR6FastaSelection\DeleteRecomb\TLR6FinalFastaDeleteRecom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0"/>
            <a:ext cx="9158856" cy="6858000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3124200" y="35116"/>
            <a:ext cx="259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/>
              <a:t>TLR6</a:t>
            </a:r>
          </a:p>
          <a:p>
            <a:pPr algn="ctr"/>
            <a:r>
              <a:rPr lang="en-US" sz="2000" dirty="0" smtClean="0"/>
              <a:t>13 SNPs: Positions 1-13</a:t>
            </a:r>
            <a:endParaRPr lang="en-US" sz="2000" dirty="0"/>
          </a:p>
        </p:txBody>
      </p:sp>
      <p:sp>
        <p:nvSpPr>
          <p:cNvPr id="4" name="TextBox 3"/>
          <p:cNvSpPr txBox="1"/>
          <p:nvPr/>
        </p:nvSpPr>
        <p:spPr>
          <a:xfrm>
            <a:off x="7362088" y="346124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8549048" y="268746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819288" y="205740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7086600" y="213360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987560" y="2998176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E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1802424" y="3121212"/>
            <a:ext cx="533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448408" y="3533001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1093176" y="4881153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3004040" y="5089241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5679832" y="4589584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762000" y="1902072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93432" y="3516868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G</a:t>
            </a:r>
            <a:endParaRPr lang="en-US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867504" y="5140516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H</a:t>
            </a:r>
            <a:endParaRPr lang="en-US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322384" y="5650468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I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52400" y="6260068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J</a:t>
            </a:r>
            <a:endParaRPr lang="en-US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1808280" y="624840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K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312984" y="332056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L</a:t>
            </a:r>
            <a:endParaRPr lang="en-US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1676400" y="4545624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M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312376" y="5884984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N</a:t>
            </a:r>
            <a:endParaRPr lang="en-US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3751384" y="6412468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O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7315200" y="502920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P</a:t>
            </a:r>
            <a:endParaRPr lang="en-US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Documents and Settings\CSeabury\Desktop\454BovineTLRResults\2011USDA_PNAS_fastasNetworks\TLR7FastaSelection\TLR7FinalFasta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-1"/>
            <a:ext cx="9144000" cy="6858001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3124200" y="35116"/>
            <a:ext cx="259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/>
              <a:t>TLR7</a:t>
            </a:r>
          </a:p>
          <a:p>
            <a:pPr algn="ctr"/>
            <a:r>
              <a:rPr lang="en-US" sz="2000" dirty="0" smtClean="0"/>
              <a:t>15 SNPs: Positions 1-15</a:t>
            </a:r>
            <a:endParaRPr lang="en-US" sz="2000" dirty="0"/>
          </a:p>
        </p:txBody>
      </p:sp>
      <p:sp>
        <p:nvSpPr>
          <p:cNvPr id="4" name="TextBox 3"/>
          <p:cNvSpPr txBox="1"/>
          <p:nvPr/>
        </p:nvSpPr>
        <p:spPr>
          <a:xfrm>
            <a:off x="5122652" y="5022008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3250722" y="4766096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6684914" y="597252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8658922" y="5978104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D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6477000" y="422407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E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5122652" y="2793522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11348" y="5996964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G</a:t>
            </a:r>
            <a:endParaRPr lang="en-US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5789766" y="1373034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H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8827140" y="4202668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I</a:t>
            </a:r>
            <a:endParaRPr lang="en-US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3555522" y="1388852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 descr="TLR9FinalFasta.bmp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124200" y="35116"/>
            <a:ext cx="259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/>
              <a:t>TLR9</a:t>
            </a:r>
          </a:p>
          <a:p>
            <a:pPr algn="ctr"/>
            <a:r>
              <a:rPr lang="en-US" sz="2000" dirty="0" smtClean="0"/>
              <a:t>22 SNPs: Positions 1-22</a:t>
            </a:r>
            <a:endParaRPr lang="en-US" sz="2000" dirty="0"/>
          </a:p>
        </p:txBody>
      </p:sp>
      <p:sp>
        <p:nvSpPr>
          <p:cNvPr id="4" name="TextBox 3"/>
          <p:cNvSpPr txBox="1"/>
          <p:nvPr/>
        </p:nvSpPr>
        <p:spPr>
          <a:xfrm>
            <a:off x="2260122" y="4935748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2857662" y="4096114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5346384" y="4702998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3238662" y="5706374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D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879122" y="6183868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E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1128616" y="510540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030862" y="3022122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G</a:t>
            </a:r>
            <a:endParaRPr lang="en-US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1647088" y="198120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H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432098" y="1278148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I</a:t>
            </a:r>
            <a:endParaRPr lang="en-US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2632496" y="1653564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J</a:t>
            </a:r>
            <a:endParaRPr lang="en-US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091904" y="3165896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K</a:t>
            </a:r>
            <a:endParaRPr lang="en-US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2041582" y="2743200"/>
            <a:ext cx="533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2777704" y="2777704"/>
            <a:ext cx="533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1524000" y="4099471"/>
            <a:ext cx="533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2590800" y="3810000"/>
            <a:ext cx="533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mv</a:t>
            </a:r>
            <a:endParaRPr lang="en-US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6858000" y="1104346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L</a:t>
            </a:r>
            <a:endParaRPr lang="en-US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7479984" y="1535668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M</a:t>
            </a:r>
            <a:endParaRPr lang="en-US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8047888" y="3094172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N</a:t>
            </a:r>
            <a:endParaRPr lang="en-US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8026878" y="4419600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O</a:t>
            </a:r>
            <a:endParaRPr lang="en-US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7226940" y="3640348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P</a:t>
            </a:r>
            <a:endParaRPr lang="en-US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6373488" y="4445478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Q</a:t>
            </a:r>
            <a:endParaRPr lang="en-US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5528096" y="3751052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R</a:t>
            </a:r>
            <a:endParaRPr lang="en-US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5760454" y="2574982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</a:t>
            </a:r>
            <a:endParaRPr lang="en-US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4746844" y="2974842"/>
            <a:ext cx="257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T</a:t>
            </a:r>
            <a:endParaRPr lang="en-US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1846</TotalTime>
  <Words>423</Words>
  <Application>Microsoft Office PowerPoint</Application>
  <PresentationFormat>On-screen Show (4:3)</PresentationFormat>
  <Paragraphs>193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exas A&amp;M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Seabury</dc:creator>
  <cp:lastModifiedBy>CSeabury</cp:lastModifiedBy>
  <cp:revision>70</cp:revision>
  <cp:lastPrinted>2011-10-16T21:59:01Z</cp:lastPrinted>
  <dcterms:created xsi:type="dcterms:W3CDTF">2010-07-04T17:13:10Z</dcterms:created>
  <dcterms:modified xsi:type="dcterms:W3CDTF">2011-11-04T15:39:11Z</dcterms:modified>
</cp:coreProperties>
</file>